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1045" r:id="rId2"/>
  </p:sldIdLst>
  <p:sldSz cx="12192000" cy="6858000"/>
  <p:notesSz cx="7011988" cy="929798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E03BD"/>
    <a:srgbClr val="E226B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3" autoAdjust="0"/>
    <p:restoredTop sz="94660"/>
  </p:normalViewPr>
  <p:slideViewPr>
    <p:cSldViewPr snapToGrid="0">
      <p:cViewPr varScale="1">
        <p:scale>
          <a:sx n="95" d="100"/>
          <a:sy n="95" d="100"/>
        </p:scale>
        <p:origin x="20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64730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03344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0792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57421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2164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63132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8207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10521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68026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79578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99371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23837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5077BB5C-1C90-4F3D-81EE-3DB93B0B1B4A}"/>
              </a:ext>
            </a:extLst>
          </p:cNvPr>
          <p:cNvSpPr txBox="1"/>
          <p:nvPr/>
        </p:nvSpPr>
        <p:spPr>
          <a:xfrm>
            <a:off x="412765" y="105059"/>
            <a:ext cx="11508618" cy="9387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0" lvl="0">
              <a:spcBef>
                <a:spcPts val="0"/>
              </a:spcBef>
              <a:spcAft>
                <a:spcPts val="0"/>
              </a:spcAft>
              <a:tabLst>
                <a:tab pos="457200" algn="l"/>
              </a:tabLst>
            </a:pP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Fig. 7 </a:t>
            </a:r>
            <a:r>
              <a:rPr lang="en-US" sz="11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Single-Cell transcriptomics; 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Identifies epithelial to mesenchymal transition (EMT) marker TGFB1 in AR</a:t>
            </a:r>
            <a:r>
              <a:rPr lang="en-US" sz="1100" kern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Low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/mCRPC/NEPC (PC-3 spheroid CONT-No treatment vs, extended exposure-EE and conventional exposure-CONV). Result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</a:rPr>
              <a:t>showe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d TGFB1 expression decreases after EE compared to CONV treatment, which indicated EE moderated stemness in 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rPr>
              <a:t>AR</a:t>
            </a:r>
            <a:r>
              <a:rPr kumimoji="0" lang="en-US" sz="1100" b="0" i="0" u="none" strike="noStrike" kern="1200" cap="none" spc="0" normalizeH="0" baseline="300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rPr>
              <a:t>Low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+mn-cs"/>
              </a:rPr>
              <a:t>/mCRPC/NEPC. 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Single-cell RNA sequencing  used the droplet sequencing method (10X Genomics). Each dot represents a single cell. t-distributed stochastic neighbor embedding (</a:t>
            </a:r>
            <a:r>
              <a:rPr lang="en-US" sz="1100" kern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tSNE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) plots showing the comparison between the single-cell clusters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</a:rPr>
              <a:t>as shown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. 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R="0" lvl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endParaRPr kumimoji="0" lang="it-IT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grpSp>
        <p:nvGrpSpPr>
          <p:cNvPr id="40" name="Group 39">
            <a:extLst>
              <a:ext uri="{FF2B5EF4-FFF2-40B4-BE49-F238E27FC236}">
                <a16:creationId xmlns:a16="http://schemas.microsoft.com/office/drawing/2014/main" id="{59BF06B5-8D07-7D6E-0890-4795A571C055}"/>
              </a:ext>
            </a:extLst>
          </p:cNvPr>
          <p:cNvGrpSpPr/>
          <p:nvPr/>
        </p:nvGrpSpPr>
        <p:grpSpPr>
          <a:xfrm>
            <a:off x="332793" y="1736188"/>
            <a:ext cx="11417673" cy="2636375"/>
            <a:chOff x="332793" y="1736188"/>
            <a:chExt cx="11417673" cy="2636375"/>
          </a:xfrm>
        </p:grpSpPr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D7D7B078-DE4F-4E87-AA3C-DFBE613EFF2F}"/>
                </a:ext>
              </a:extLst>
            </p:cNvPr>
            <p:cNvGrpSpPr/>
            <p:nvPr/>
          </p:nvGrpSpPr>
          <p:grpSpPr>
            <a:xfrm>
              <a:off x="412765" y="1736188"/>
              <a:ext cx="11337701" cy="2598669"/>
              <a:chOff x="412765" y="830331"/>
              <a:chExt cx="11337701" cy="2598669"/>
            </a:xfrm>
          </p:grpSpPr>
          <p:grpSp>
            <p:nvGrpSpPr>
              <p:cNvPr id="2" name="Group 1">
                <a:extLst>
                  <a:ext uri="{FF2B5EF4-FFF2-40B4-BE49-F238E27FC236}">
                    <a16:creationId xmlns:a16="http://schemas.microsoft.com/office/drawing/2014/main" id="{71BF8F2D-2E9A-46CB-BF34-A422CAE34310}"/>
                  </a:ext>
                </a:extLst>
              </p:cNvPr>
              <p:cNvGrpSpPr/>
              <p:nvPr/>
            </p:nvGrpSpPr>
            <p:grpSpPr>
              <a:xfrm>
                <a:off x="412765" y="830331"/>
                <a:ext cx="11337701" cy="2598669"/>
                <a:chOff x="504201" y="1563135"/>
                <a:chExt cx="11337701" cy="2598669"/>
              </a:xfrm>
            </p:grpSpPr>
            <p:pic>
              <p:nvPicPr>
                <p:cNvPr id="3" name="Picture 2" descr="Graphical user interface, application&#10;&#10;Description automatically generated">
                  <a:extLst>
                    <a:ext uri="{FF2B5EF4-FFF2-40B4-BE49-F238E27FC236}">
                      <a16:creationId xmlns:a16="http://schemas.microsoft.com/office/drawing/2014/main" id="{DB358CA9-71A2-48CE-B44B-D9C16EFD929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5000" t="8378" r="67757" b="48577"/>
                <a:stretch/>
              </p:blipFill>
              <p:spPr>
                <a:xfrm>
                  <a:off x="504201" y="1563135"/>
                  <a:ext cx="2726107" cy="2598669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4" name="Picture 3" descr="Graphical user interface, application&#10;&#10;Description automatically generated">
                  <a:extLst>
                    <a:ext uri="{FF2B5EF4-FFF2-40B4-BE49-F238E27FC236}">
                      <a16:creationId xmlns:a16="http://schemas.microsoft.com/office/drawing/2014/main" id="{5D4DD99A-A482-4458-90A9-C6575BC30C7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5224" t="8378" r="17710" b="48577"/>
                <a:stretch/>
              </p:blipFill>
              <p:spPr>
                <a:xfrm>
                  <a:off x="3262906" y="1567936"/>
                  <a:ext cx="2713577" cy="2588747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5" name="Picture 4" descr="Graphical user interface, application&#10;&#10;Description automatically generated">
                  <a:extLst>
                    <a:ext uri="{FF2B5EF4-FFF2-40B4-BE49-F238E27FC236}">
                      <a16:creationId xmlns:a16="http://schemas.microsoft.com/office/drawing/2014/main" id="{826C65CD-DF3D-4D35-A925-9B8C2D1C47D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5091" t="56705" r="67687"/>
                <a:stretch/>
              </p:blipFill>
              <p:spPr>
                <a:xfrm>
                  <a:off x="6012294" y="1567936"/>
                  <a:ext cx="2696742" cy="2588746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6" name="Picture 5" descr="Graphical user interface, application&#10;&#10;Description automatically generated">
                  <a:extLst>
                    <a:ext uri="{FF2B5EF4-FFF2-40B4-BE49-F238E27FC236}">
                      <a16:creationId xmlns:a16="http://schemas.microsoft.com/office/drawing/2014/main" id="{4BA75DC1-164B-4954-99C3-0B4E7534735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5023" t="4798" r="429" b="71523"/>
                <a:stretch/>
              </p:blipFill>
              <p:spPr>
                <a:xfrm>
                  <a:off x="8746278" y="1567936"/>
                  <a:ext cx="1773596" cy="1102408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7" name="Picture 6" descr="Table&#10;&#10;Description automatically generated">
                  <a:extLst>
                    <a:ext uri="{FF2B5EF4-FFF2-40B4-BE49-F238E27FC236}">
                      <a16:creationId xmlns:a16="http://schemas.microsoft.com/office/drawing/2014/main" id="{D45EAD02-3847-41A9-8F52-85951C165A3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746277" y="2723018"/>
                  <a:ext cx="3095625" cy="1419225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A346A54F-D3A7-4626-B756-2C3B2F805A99}"/>
                  </a:ext>
                </a:extLst>
              </p:cNvPr>
              <p:cNvSpPr txBox="1"/>
              <p:nvPr/>
            </p:nvSpPr>
            <p:spPr>
              <a:xfrm>
                <a:off x="1067370" y="830331"/>
                <a:ext cx="182293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CONTROL (CONT)-Week 6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28344025-E5E6-4E62-9B56-99885544281A}"/>
                  </a:ext>
                </a:extLst>
              </p:cNvPr>
              <p:cNvSpPr txBox="1"/>
              <p:nvPr/>
            </p:nvSpPr>
            <p:spPr>
              <a:xfrm>
                <a:off x="3715420" y="830331"/>
                <a:ext cx="218681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Extended Exposure (EE)-Week 6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45DD8762-B87B-4413-83B9-1583A1275475}"/>
                  </a:ext>
                </a:extLst>
              </p:cNvPr>
              <p:cNvSpPr txBox="1"/>
              <p:nvPr/>
            </p:nvSpPr>
            <p:spPr>
              <a:xfrm>
                <a:off x="6478785" y="830331"/>
                <a:ext cx="197041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Conventional (CONV)-Week 6</a:t>
                </a:r>
              </a:p>
            </p:txBody>
          </p:sp>
          <p:sp>
            <p:nvSpPr>
              <p:cNvPr id="9" name="Rectangle 8">
                <a:extLst>
                  <a:ext uri="{FF2B5EF4-FFF2-40B4-BE49-F238E27FC236}">
                    <a16:creationId xmlns:a16="http://schemas.microsoft.com/office/drawing/2014/main" id="{00E9F639-3DD6-49EB-9972-797CB35DC19C}"/>
                  </a:ext>
                </a:extLst>
              </p:cNvPr>
              <p:cNvSpPr/>
              <p:nvPr/>
            </p:nvSpPr>
            <p:spPr>
              <a:xfrm>
                <a:off x="8913264" y="2486826"/>
                <a:ext cx="376015" cy="16237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" name="Rectangle 14">
                <a:extLst>
                  <a:ext uri="{FF2B5EF4-FFF2-40B4-BE49-F238E27FC236}">
                    <a16:creationId xmlns:a16="http://schemas.microsoft.com/office/drawing/2014/main" id="{371B6833-81EC-4766-8761-79EEA5778695}"/>
                  </a:ext>
                </a:extLst>
              </p:cNvPr>
              <p:cNvSpPr/>
              <p:nvPr/>
            </p:nvSpPr>
            <p:spPr>
              <a:xfrm>
                <a:off x="8913263" y="2982014"/>
                <a:ext cx="376015" cy="16237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" name="Rectangle 15">
                <a:extLst>
                  <a:ext uri="{FF2B5EF4-FFF2-40B4-BE49-F238E27FC236}">
                    <a16:creationId xmlns:a16="http://schemas.microsoft.com/office/drawing/2014/main" id="{9D8B9EEF-49FC-4583-AD18-29F6E2285A5D}"/>
                  </a:ext>
                </a:extLst>
              </p:cNvPr>
              <p:cNvSpPr/>
              <p:nvPr/>
            </p:nvSpPr>
            <p:spPr>
              <a:xfrm>
                <a:off x="8913263" y="2742128"/>
                <a:ext cx="376015" cy="162370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D5BABCCE-E1CE-49A6-A5FC-FD327E9F41BB}"/>
                  </a:ext>
                </a:extLst>
              </p:cNvPr>
              <p:cNvSpPr txBox="1"/>
              <p:nvPr/>
            </p:nvSpPr>
            <p:spPr>
              <a:xfrm>
                <a:off x="8855319" y="2459981"/>
                <a:ext cx="54854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solidFill>
                      <a:schemeClr val="bg2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NT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E4B6873B-5ABD-45FE-833B-978E8D63BFF9}"/>
                  </a:ext>
                </a:extLst>
              </p:cNvPr>
              <p:cNvSpPr txBox="1"/>
              <p:nvPr/>
            </p:nvSpPr>
            <p:spPr>
              <a:xfrm>
                <a:off x="8855319" y="2957172"/>
                <a:ext cx="55496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solidFill>
                      <a:schemeClr val="bg2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NV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DC62EBA7-8954-4C7C-B4F6-88C751E4683E}"/>
                  </a:ext>
                </a:extLst>
              </p:cNvPr>
              <p:cNvSpPr txBox="1"/>
              <p:nvPr/>
            </p:nvSpPr>
            <p:spPr>
              <a:xfrm>
                <a:off x="8952301" y="2699826"/>
                <a:ext cx="35458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solidFill>
                      <a:schemeClr val="bg2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E</a:t>
                </a:r>
              </a:p>
            </p:txBody>
          </p:sp>
        </p:grp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FEE35D5A-E5BE-379E-9836-FB851A45832D}"/>
                </a:ext>
              </a:extLst>
            </p:cNvPr>
            <p:cNvSpPr/>
            <p:nvPr/>
          </p:nvSpPr>
          <p:spPr>
            <a:xfrm>
              <a:off x="412765" y="2530383"/>
              <a:ext cx="185441" cy="68283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87ABE253-BC46-3C74-F0A9-B40BD7725F43}"/>
                </a:ext>
              </a:extLst>
            </p:cNvPr>
            <p:cNvSpPr txBox="1"/>
            <p:nvPr/>
          </p:nvSpPr>
          <p:spPr>
            <a:xfrm rot="16200000">
              <a:off x="124225" y="2815789"/>
              <a:ext cx="8386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D t-SNE 2</a:t>
              </a: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C7F87A1E-B672-209B-A00F-2A920F45E6C9}"/>
                </a:ext>
              </a:extLst>
            </p:cNvPr>
            <p:cNvSpPr/>
            <p:nvPr/>
          </p:nvSpPr>
          <p:spPr>
            <a:xfrm>
              <a:off x="420460" y="4110063"/>
              <a:ext cx="646910" cy="1713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924A8DD0-A177-B370-0552-0498E6BB75CA}"/>
                </a:ext>
              </a:extLst>
            </p:cNvPr>
            <p:cNvSpPr txBox="1"/>
            <p:nvPr/>
          </p:nvSpPr>
          <p:spPr>
            <a:xfrm>
              <a:off x="332793" y="4024603"/>
              <a:ext cx="8386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D t-SNE 3</a:t>
              </a:r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DDE88661-2EFF-DFFA-06DE-80B4A4A4CEA8}"/>
                </a:ext>
              </a:extLst>
            </p:cNvPr>
            <p:cNvSpPr/>
            <p:nvPr/>
          </p:nvSpPr>
          <p:spPr>
            <a:xfrm>
              <a:off x="1674976" y="4152440"/>
              <a:ext cx="646910" cy="16285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9C5A8883-46C6-776E-6A1A-A64C3CA5C745}"/>
                </a:ext>
              </a:extLst>
            </p:cNvPr>
            <p:cNvSpPr txBox="1"/>
            <p:nvPr/>
          </p:nvSpPr>
          <p:spPr>
            <a:xfrm>
              <a:off x="1525828" y="4126342"/>
              <a:ext cx="8386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D t-SNE 1</a:t>
              </a:r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96CC6851-D85E-6BD5-EB98-4FF185C8186B}"/>
                </a:ext>
              </a:extLst>
            </p:cNvPr>
            <p:cNvSpPr/>
            <p:nvPr/>
          </p:nvSpPr>
          <p:spPr>
            <a:xfrm>
              <a:off x="3171470" y="2530383"/>
              <a:ext cx="169936" cy="68283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1F66A323-5524-095E-FE64-8A66CB5CB41F}"/>
                </a:ext>
              </a:extLst>
            </p:cNvPr>
            <p:cNvSpPr/>
            <p:nvPr/>
          </p:nvSpPr>
          <p:spPr>
            <a:xfrm>
              <a:off x="3171469" y="4110063"/>
              <a:ext cx="605771" cy="15221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B6A8E3AD-09AC-F5FB-1872-76A84DA674FB}"/>
                </a:ext>
              </a:extLst>
            </p:cNvPr>
            <p:cNvSpPr/>
            <p:nvPr/>
          </p:nvSpPr>
          <p:spPr>
            <a:xfrm>
              <a:off x="4426721" y="4152440"/>
              <a:ext cx="605771" cy="17729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C156B5C1-C538-EC56-026E-530CE8668F12}"/>
                </a:ext>
              </a:extLst>
            </p:cNvPr>
            <p:cNvSpPr txBox="1"/>
            <p:nvPr/>
          </p:nvSpPr>
          <p:spPr>
            <a:xfrm>
              <a:off x="4259344" y="4124269"/>
              <a:ext cx="8386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D t-SNE 1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8BECE642-7276-DE42-0224-4FB1BCDF19CC}"/>
                </a:ext>
              </a:extLst>
            </p:cNvPr>
            <p:cNvSpPr txBox="1"/>
            <p:nvPr/>
          </p:nvSpPr>
          <p:spPr>
            <a:xfrm>
              <a:off x="3084996" y="4033954"/>
              <a:ext cx="8386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D t-SNE 3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2530F790-7EEC-0240-DBEC-FFC0BC195503}"/>
                </a:ext>
              </a:extLst>
            </p:cNvPr>
            <p:cNvSpPr txBox="1"/>
            <p:nvPr/>
          </p:nvSpPr>
          <p:spPr>
            <a:xfrm rot="16200000">
              <a:off x="2837092" y="2823382"/>
              <a:ext cx="8386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D t-SNE 2</a:t>
              </a:r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09430A1B-C522-C06E-5FB0-A7589790D017}"/>
                </a:ext>
              </a:extLst>
            </p:cNvPr>
            <p:cNvSpPr/>
            <p:nvPr/>
          </p:nvSpPr>
          <p:spPr>
            <a:xfrm>
              <a:off x="7144284" y="4186170"/>
              <a:ext cx="635588" cy="1291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A02B516E-2607-9C83-5468-7EFD8876C852}"/>
                </a:ext>
              </a:extLst>
            </p:cNvPr>
            <p:cNvSpPr/>
            <p:nvPr/>
          </p:nvSpPr>
          <p:spPr>
            <a:xfrm>
              <a:off x="5920858" y="4100704"/>
              <a:ext cx="594274" cy="1291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62F79D17-1E06-5E04-1590-40C0C9B2934F}"/>
                </a:ext>
              </a:extLst>
            </p:cNvPr>
            <p:cNvSpPr/>
            <p:nvPr/>
          </p:nvSpPr>
          <p:spPr>
            <a:xfrm>
              <a:off x="5970451" y="2527146"/>
              <a:ext cx="125549" cy="68607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41175234-A62D-1583-F802-23E9DBE9035D}"/>
                </a:ext>
              </a:extLst>
            </p:cNvPr>
            <p:cNvSpPr txBox="1"/>
            <p:nvPr/>
          </p:nvSpPr>
          <p:spPr>
            <a:xfrm rot="16200000">
              <a:off x="5621410" y="2804322"/>
              <a:ext cx="8386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D t-SNE 2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B235977F-E533-9F59-C528-871C19EE3FE2}"/>
                </a:ext>
              </a:extLst>
            </p:cNvPr>
            <p:cNvSpPr txBox="1"/>
            <p:nvPr/>
          </p:nvSpPr>
          <p:spPr>
            <a:xfrm>
              <a:off x="5818512" y="4024602"/>
              <a:ext cx="8386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D t-SNE 3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BA0802BB-77BC-73BC-ECCB-D000D60F94E2}"/>
                </a:ext>
              </a:extLst>
            </p:cNvPr>
            <p:cNvSpPr txBox="1"/>
            <p:nvPr/>
          </p:nvSpPr>
          <p:spPr>
            <a:xfrm>
              <a:off x="7087241" y="4124269"/>
              <a:ext cx="8386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D t-SNE 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09242494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36</TotalTime>
  <Words>147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1_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raswi Mitra Ghosh</dc:creator>
  <cp:lastModifiedBy>AMIT MITRA</cp:lastModifiedBy>
  <cp:revision>114</cp:revision>
  <cp:lastPrinted>2022-04-06T04:19:54Z</cp:lastPrinted>
  <dcterms:created xsi:type="dcterms:W3CDTF">2021-11-23T16:14:52Z</dcterms:created>
  <dcterms:modified xsi:type="dcterms:W3CDTF">2023-05-31T16:11:17Z</dcterms:modified>
</cp:coreProperties>
</file>